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0" y="5828826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4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for Cancer-specific survival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GPS 1-2, low hemoglobin, NLR (≥ 5), PLR (≥150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w transferrin. Backward stepwise elimination (likelihood method) with a threshold of P = 0.20 was used to select variables for the final model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1C8C935B-C888-46EA-962C-B27B9CCA4E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5814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9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9</cp:revision>
  <dcterms:created xsi:type="dcterms:W3CDTF">2020-05-05T12:02:23Z</dcterms:created>
  <dcterms:modified xsi:type="dcterms:W3CDTF">2020-09-27T10:42:38Z</dcterms:modified>
</cp:coreProperties>
</file>